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752013" cy="130032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AD1E2-ED40-4CEE-ADCA-45B4AB7E30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69600" y="3462120"/>
            <a:ext cx="841356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69600" y="7771680"/>
            <a:ext cx="841356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5D0BE-5D51-445D-8779-F63E456E47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69600" y="346212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980960" y="346212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69600" y="777168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980960" y="777168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FDAE67-1BBA-483D-A7FE-DE2F031D79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69600" y="3462120"/>
            <a:ext cx="27090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14320" y="3462120"/>
            <a:ext cx="27090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359400" y="3462120"/>
            <a:ext cx="27090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69600" y="7771680"/>
            <a:ext cx="27090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14320" y="7771680"/>
            <a:ext cx="27090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359400" y="7771680"/>
            <a:ext cx="27090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75B84F-2750-4EBF-B458-BE17FCE77BF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69600" y="3462120"/>
            <a:ext cx="8413560" cy="8250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63"/>
              </a:spcBef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E1002-4072-46E0-AE17-B765EA037B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69600" y="3462120"/>
            <a:ext cx="8413560" cy="825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C125E-6832-4255-A760-9C3392185F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69600" y="3462120"/>
            <a:ext cx="4105800" cy="825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980960" y="3462120"/>
            <a:ext cx="4105800" cy="825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10D1A-CC41-4F9A-9C60-4D03E7F6A2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87CE6-2DD4-458C-8163-277ADC0096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69600" y="691920"/>
            <a:ext cx="8413560" cy="11657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63"/>
              </a:spcBef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17CDB-5FE5-4674-809B-CF7BD5462B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69600" y="346212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980960" y="3462120"/>
            <a:ext cx="4105800" cy="825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69600" y="777168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C6CB4-DCF5-4C1C-A009-6535E6ED8B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69600" y="3462120"/>
            <a:ext cx="4105800" cy="825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980960" y="346212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980960" y="777168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69E81-B949-43F6-9207-0E1EA3CCDF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69600" y="346212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980960" y="3462120"/>
            <a:ext cx="410580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69600" y="7771680"/>
            <a:ext cx="8413560" cy="393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63"/>
              </a:spcBef>
              <a:buNone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B6865-2880-4F47-99B0-DE28FF1F74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69600" y="691920"/>
            <a:ext cx="841356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69600" y="3462120"/>
            <a:ext cx="8413560" cy="825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43000" indent="-243000">
              <a:lnSpc>
                <a:spcPct val="90000"/>
              </a:lnSpc>
              <a:spcBef>
                <a:spcPts val="1063"/>
              </a:spcBef>
              <a:buClr>
                <a:srgbClr val="000000"/>
              </a:buClr>
              <a:buFont typeface="Arial"/>
              <a:buChar char="•"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1" marL="730080" indent="-242640">
              <a:lnSpc>
                <a:spcPct val="90000"/>
              </a:lnSpc>
              <a:spcBef>
                <a:spcPts val="1063"/>
              </a:spcBef>
              <a:buClr>
                <a:srgbClr val="000000"/>
              </a:buClr>
              <a:buFont typeface="Arial"/>
              <a:buChar char="•"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2" marL="1219320" indent="-243000">
              <a:lnSpc>
                <a:spcPct val="90000"/>
              </a:lnSpc>
              <a:spcBef>
                <a:spcPts val="1063"/>
              </a:spcBef>
              <a:buClr>
                <a:srgbClr val="000000"/>
              </a:buClr>
              <a:buFont typeface="Arial"/>
              <a:buChar char="•"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3" marL="1706400" indent="-242640">
              <a:lnSpc>
                <a:spcPct val="90000"/>
              </a:lnSpc>
              <a:spcBef>
                <a:spcPts val="1063"/>
              </a:spcBef>
              <a:buClr>
                <a:srgbClr val="000000"/>
              </a:buClr>
              <a:buFont typeface="Arial"/>
              <a:buChar char="•"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4" marL="2193840" indent="-242640">
              <a:lnSpc>
                <a:spcPct val="90000"/>
              </a:lnSpc>
              <a:spcBef>
                <a:spcPts val="1063"/>
              </a:spcBef>
              <a:buClr>
                <a:srgbClr val="000000"/>
              </a:buClr>
              <a:buFont typeface="Arial"/>
              <a:buChar char="•"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5" marL="2193840" indent="-242640">
              <a:lnSpc>
                <a:spcPct val="90000"/>
              </a:lnSpc>
              <a:spcBef>
                <a:spcPts val="1063"/>
              </a:spcBef>
              <a:buClr>
                <a:srgbClr val="000000"/>
              </a:buClr>
              <a:buFont typeface="Arial"/>
              <a:buChar char="•"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6" marL="2193840" indent="-242640">
              <a:lnSpc>
                <a:spcPct val="90000"/>
              </a:lnSpc>
              <a:spcBef>
                <a:spcPts val="1063"/>
              </a:spcBef>
              <a:buClr>
                <a:srgbClr val="000000"/>
              </a:buClr>
              <a:buFont typeface="Arial"/>
              <a:buChar char="•"/>
              <a:tabLst>
                <a:tab algn="l" pos="974880"/>
                <a:tab algn="l" pos="1949400"/>
                <a:tab algn="l" pos="2924280"/>
                <a:tab algn="l" pos="3898800"/>
                <a:tab algn="l" pos="4873680"/>
                <a:tab algn="l" pos="5848200"/>
                <a:tab algn="l" pos="6823080"/>
                <a:tab algn="l" pos="7797960"/>
                <a:tab algn="l" pos="8772480"/>
                <a:tab algn="l" pos="9747360"/>
                <a:tab algn="l" pos="1072188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69600" y="12053520"/>
            <a:ext cx="2195640" cy="69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30640" y="12053520"/>
            <a:ext cx="3292560" cy="69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888240" y="12053520"/>
            <a:ext cx="2195280" cy="69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FEBA1F9-B47D-44DE-8E88-D74EBD8337C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0" t="0" r="0" b="10157"/>
          <a:stretch/>
        </p:blipFill>
        <p:spPr>
          <a:xfrm>
            <a:off x="-6480" y="939960"/>
            <a:ext cx="9753840" cy="1168380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4"/>
          <p:cNvSpPr/>
          <p:nvPr/>
        </p:nvSpPr>
        <p:spPr>
          <a:xfrm>
            <a:off x="242280" y="25416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Rectangle 4"/>
          <p:cNvSpPr/>
          <p:nvPr/>
        </p:nvSpPr>
        <p:spPr>
          <a:xfrm>
            <a:off x="242280" y="25416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3" descr=""/>
          <p:cNvPicPr/>
          <p:nvPr/>
        </p:nvPicPr>
        <p:blipFill>
          <a:blip r:embed="rId1"/>
          <a:stretch/>
        </p:blipFill>
        <p:spPr>
          <a:xfrm>
            <a:off x="19080" y="1397160"/>
            <a:ext cx="9753480" cy="7315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"/>
          <p:cNvSpPr/>
          <p:nvPr/>
        </p:nvSpPr>
        <p:spPr>
          <a:xfrm>
            <a:off x="242280" y="25416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2" descr=""/>
          <p:cNvPicPr/>
          <p:nvPr/>
        </p:nvPicPr>
        <p:blipFill>
          <a:blip r:embed="rId1"/>
          <a:srcRect l="0" t="0" r="0" b="25979"/>
          <a:stretch/>
        </p:blipFill>
        <p:spPr>
          <a:xfrm>
            <a:off x="0" y="1015920"/>
            <a:ext cx="9753480" cy="9626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"/>
          <p:cNvSpPr/>
          <p:nvPr/>
        </p:nvSpPr>
        <p:spPr>
          <a:xfrm>
            <a:off x="242280" y="25416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3" descr=""/>
          <p:cNvPicPr/>
          <p:nvPr/>
        </p:nvPicPr>
        <p:blipFill>
          <a:blip r:embed="rId1"/>
          <a:srcRect l="11719" t="4163" r="13280" b="7290"/>
          <a:stretch/>
        </p:blipFill>
        <p:spPr>
          <a:xfrm>
            <a:off x="230040" y="1625760"/>
            <a:ext cx="9293400" cy="8229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"/>
          <p:cNvSpPr/>
          <p:nvPr/>
        </p:nvSpPr>
        <p:spPr>
          <a:xfrm>
            <a:off x="242280" y="25416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2" descr=""/>
          <p:cNvPicPr/>
          <p:nvPr/>
        </p:nvPicPr>
        <p:blipFill>
          <a:blip r:embed="rId1"/>
          <a:srcRect l="0" t="0" r="0" b="18362"/>
          <a:stretch/>
        </p:blipFill>
        <p:spPr>
          <a:xfrm>
            <a:off x="0" y="787320"/>
            <a:ext cx="9753480" cy="10617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Mhd_Bashawat</dc:creator>
  <dc:description/>
  <dc:language>en-US</dc:language>
  <cp:lastModifiedBy>Mohammad Bashawat</cp:lastModifiedBy>
  <cp:lastPrinted>2022-12-16T14:58:26Z</cp:lastPrinted>
  <dcterms:modified xsi:type="dcterms:W3CDTF">2022-12-21T15:54:49Z</dcterms:modified>
  <cp:revision>15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